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05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5EC77-CDE6-480D-BF21-D635A7A7038A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96D5A-DCBE-40E8-8C51-1EFE6E633F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3269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5EC77-CDE6-480D-BF21-D635A7A7038A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96D5A-DCBE-40E8-8C51-1EFE6E633F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72303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5EC77-CDE6-480D-BF21-D635A7A7038A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96D5A-DCBE-40E8-8C51-1EFE6E633F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3293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5EC77-CDE6-480D-BF21-D635A7A7038A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96D5A-DCBE-40E8-8C51-1EFE6E633F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3998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5EC77-CDE6-480D-BF21-D635A7A7038A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96D5A-DCBE-40E8-8C51-1EFE6E633F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14191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5EC77-CDE6-480D-BF21-D635A7A7038A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96D5A-DCBE-40E8-8C51-1EFE6E633F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28326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5EC77-CDE6-480D-BF21-D635A7A7038A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96D5A-DCBE-40E8-8C51-1EFE6E633F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5741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5EC77-CDE6-480D-BF21-D635A7A7038A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96D5A-DCBE-40E8-8C51-1EFE6E633F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32420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5EC77-CDE6-480D-BF21-D635A7A7038A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96D5A-DCBE-40E8-8C51-1EFE6E633F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0259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5EC77-CDE6-480D-BF21-D635A7A7038A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96D5A-DCBE-40E8-8C51-1EFE6E633F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6542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5EC77-CDE6-480D-BF21-D635A7A7038A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796D5A-DCBE-40E8-8C51-1EFE6E633F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7665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35EC77-CDE6-480D-BF21-D635A7A7038A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796D5A-DCBE-40E8-8C51-1EFE6E633F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1822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683568" y="404664"/>
            <a:ext cx="81369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S6 Amino acid sequence alignment of melon </a:t>
            </a:r>
            <a:r>
              <a:rPr lang="en-US" altLang="zh-CN" b="1" i="1" dirty="0"/>
              <a:t>CmADH7 </a:t>
            </a:r>
            <a:r>
              <a:rPr lang="en-US" altLang="zh-CN" b="1" dirty="0"/>
              <a:t>(MELO3C002189P1) with closely related sequences of other plants. </a:t>
            </a:r>
            <a:endParaRPr lang="zh-CN" altLang="en-US" dirty="0"/>
          </a:p>
        </p:txBody>
      </p:sp>
      <p:sp>
        <p:nvSpPr>
          <p:cNvPr id="5" name="Rectangle 24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pic>
        <p:nvPicPr>
          <p:cNvPr id="29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41431" y="6093296"/>
            <a:ext cx="2425700" cy="520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5478" y="1296775"/>
            <a:ext cx="7477843" cy="35113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" name="Rectangle 19"/>
          <p:cNvSpPr>
            <a:spLocks noChangeArrowheads="1"/>
          </p:cNvSpPr>
          <p:nvPr/>
        </p:nvSpPr>
        <p:spPr bwMode="auto">
          <a:xfrm>
            <a:off x="7272828" y="1306796"/>
            <a:ext cx="831602" cy="1152128"/>
          </a:xfrm>
          <a:prstGeom prst="rect">
            <a:avLst/>
          </a:prstGeom>
          <a:noFill/>
          <a:ln w="28575">
            <a:solidFill>
              <a:srgbClr val="FF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31" name="Rectangle 19"/>
          <p:cNvSpPr>
            <a:spLocks noChangeArrowheads="1"/>
          </p:cNvSpPr>
          <p:nvPr/>
        </p:nvSpPr>
        <p:spPr bwMode="auto">
          <a:xfrm>
            <a:off x="1672649" y="2458924"/>
            <a:ext cx="648072" cy="1187038"/>
          </a:xfrm>
          <a:prstGeom prst="rect">
            <a:avLst/>
          </a:prstGeom>
          <a:noFill/>
          <a:ln w="28575">
            <a:solidFill>
              <a:srgbClr val="FF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32" name="Rectangle 17"/>
          <p:cNvSpPr>
            <a:spLocks noChangeArrowheads="1"/>
          </p:cNvSpPr>
          <p:nvPr/>
        </p:nvSpPr>
        <p:spPr bwMode="auto">
          <a:xfrm>
            <a:off x="2691923" y="2458924"/>
            <a:ext cx="2221085" cy="1187038"/>
          </a:xfrm>
          <a:prstGeom prst="rect">
            <a:avLst/>
          </a:prstGeom>
          <a:noFill/>
          <a:ln w="28575">
            <a:solidFill>
              <a:srgbClr val="FF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33" name="Rectangle 16"/>
          <p:cNvSpPr>
            <a:spLocks noChangeArrowheads="1"/>
          </p:cNvSpPr>
          <p:nvPr/>
        </p:nvSpPr>
        <p:spPr bwMode="auto">
          <a:xfrm>
            <a:off x="5617005" y="3645962"/>
            <a:ext cx="536930" cy="1189226"/>
          </a:xfrm>
          <a:prstGeom prst="rect">
            <a:avLst/>
          </a:prstGeom>
          <a:noFill/>
          <a:ln w="28575">
            <a:solidFill>
              <a:srgbClr val="FF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34" name="Rectangle 5"/>
          <p:cNvSpPr>
            <a:spLocks noChangeArrowheads="1"/>
          </p:cNvSpPr>
          <p:nvPr/>
        </p:nvSpPr>
        <p:spPr bwMode="auto">
          <a:xfrm>
            <a:off x="5800629" y="1382339"/>
            <a:ext cx="248941" cy="1929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3950" tIns="26975" rIns="53950" bIns="26975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▽</a:t>
            </a:r>
            <a:endParaRPr kumimoji="0" lang="zh-CN" altLang="zh-CN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35" name="Rectangle 5"/>
          <p:cNvSpPr>
            <a:spLocks noChangeArrowheads="1"/>
          </p:cNvSpPr>
          <p:nvPr/>
        </p:nvSpPr>
        <p:spPr bwMode="auto">
          <a:xfrm>
            <a:off x="7249759" y="1382339"/>
            <a:ext cx="248941" cy="1929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3950" tIns="26975" rIns="53950" bIns="26975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▽</a:t>
            </a:r>
            <a:endParaRPr kumimoji="0" lang="zh-CN" altLang="zh-CN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36" name="Rectangle 5"/>
          <p:cNvSpPr>
            <a:spLocks noChangeArrowheads="1"/>
          </p:cNvSpPr>
          <p:nvPr/>
        </p:nvSpPr>
        <p:spPr bwMode="auto">
          <a:xfrm>
            <a:off x="7374229" y="1382339"/>
            <a:ext cx="248941" cy="1929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3950" tIns="26975" rIns="53950" bIns="26975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▽</a:t>
            </a:r>
            <a:endParaRPr kumimoji="0" lang="zh-CN" altLang="zh-CN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37" name="Rectangle 11"/>
          <p:cNvSpPr>
            <a:spLocks noChangeArrowheads="1"/>
          </p:cNvSpPr>
          <p:nvPr/>
        </p:nvSpPr>
        <p:spPr bwMode="auto">
          <a:xfrm>
            <a:off x="3500278" y="2584420"/>
            <a:ext cx="236737" cy="1809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2080" tIns="21041" rIns="42080" bIns="21041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▼</a:t>
            </a:r>
            <a:endParaRPr kumimoji="0" lang="zh-CN" altLang="zh-CN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38" name="Rectangle 11"/>
          <p:cNvSpPr>
            <a:spLocks noChangeArrowheads="1"/>
          </p:cNvSpPr>
          <p:nvPr/>
        </p:nvSpPr>
        <p:spPr bwMode="auto">
          <a:xfrm>
            <a:off x="3737015" y="2584420"/>
            <a:ext cx="236737" cy="1809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2080" tIns="21041" rIns="42080" bIns="21041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▼</a:t>
            </a:r>
            <a:endParaRPr kumimoji="0" lang="zh-CN" altLang="zh-CN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39" name="Rectangle 11"/>
          <p:cNvSpPr>
            <a:spLocks noChangeArrowheads="1"/>
          </p:cNvSpPr>
          <p:nvPr/>
        </p:nvSpPr>
        <p:spPr bwMode="auto">
          <a:xfrm>
            <a:off x="3973752" y="2584420"/>
            <a:ext cx="236737" cy="1809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2080" tIns="21041" rIns="42080" bIns="21041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▼</a:t>
            </a:r>
            <a:endParaRPr kumimoji="0" lang="zh-CN" altLang="zh-CN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0" name="Rectangle 11"/>
          <p:cNvSpPr>
            <a:spLocks noChangeArrowheads="1"/>
          </p:cNvSpPr>
          <p:nvPr/>
        </p:nvSpPr>
        <p:spPr bwMode="auto">
          <a:xfrm>
            <a:off x="4676271" y="2584420"/>
            <a:ext cx="236737" cy="1809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2080" tIns="21041" rIns="42080" bIns="21041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▼</a:t>
            </a:r>
            <a:endParaRPr kumimoji="0" lang="zh-CN" altLang="zh-CN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1" name="Rectangle 3"/>
          <p:cNvSpPr>
            <a:spLocks noChangeArrowheads="1"/>
          </p:cNvSpPr>
          <p:nvPr/>
        </p:nvSpPr>
        <p:spPr bwMode="auto">
          <a:xfrm>
            <a:off x="5550194" y="3752468"/>
            <a:ext cx="133622" cy="1639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0460" tIns="20231" rIns="40460" bIns="20231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●</a:t>
            </a:r>
            <a:endParaRPr kumimoji="0" lang="zh-CN" altLang="zh-CN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2" name="Rectangle 3"/>
          <p:cNvSpPr>
            <a:spLocks noChangeArrowheads="1"/>
          </p:cNvSpPr>
          <p:nvPr/>
        </p:nvSpPr>
        <p:spPr bwMode="auto">
          <a:xfrm>
            <a:off x="5745773" y="3747268"/>
            <a:ext cx="133622" cy="1639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0460" tIns="20231" rIns="40460" bIns="20231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●</a:t>
            </a:r>
            <a:endParaRPr kumimoji="0" lang="zh-CN" altLang="zh-CN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3" name="Rectangle 3"/>
          <p:cNvSpPr>
            <a:spLocks noChangeArrowheads="1"/>
          </p:cNvSpPr>
          <p:nvPr/>
        </p:nvSpPr>
        <p:spPr bwMode="auto">
          <a:xfrm>
            <a:off x="5978292" y="3747268"/>
            <a:ext cx="133622" cy="1639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0460" tIns="20231" rIns="40460" bIns="20231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●</a:t>
            </a:r>
            <a:endParaRPr kumimoji="0" lang="zh-CN" altLang="zh-CN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4" name="Text Box 12"/>
          <p:cNvSpPr txBox="1">
            <a:spLocks noChangeArrowheads="1"/>
          </p:cNvSpPr>
          <p:nvPr/>
        </p:nvSpPr>
        <p:spPr bwMode="auto">
          <a:xfrm>
            <a:off x="6870116" y="2468571"/>
            <a:ext cx="1637026" cy="2083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3950" tIns="26975" rIns="53950" bIns="26975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Zn1 binding motif</a:t>
            </a:r>
            <a:endParaRPr kumimoji="0" lang="en-US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5" name="Text Box 12"/>
          <p:cNvSpPr txBox="1">
            <a:spLocks noChangeArrowheads="1"/>
          </p:cNvSpPr>
          <p:nvPr/>
        </p:nvSpPr>
        <p:spPr bwMode="auto">
          <a:xfrm>
            <a:off x="1312609" y="3625899"/>
            <a:ext cx="1637026" cy="253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3950" tIns="26975" rIns="53950" bIns="26975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Zn1 binding motif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6" name="Text Box 15"/>
          <p:cNvSpPr txBox="1">
            <a:spLocks noChangeArrowheads="1"/>
          </p:cNvSpPr>
          <p:nvPr/>
        </p:nvSpPr>
        <p:spPr bwMode="auto">
          <a:xfrm>
            <a:off x="2932839" y="3641272"/>
            <a:ext cx="1845087" cy="2525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3950" tIns="26975" rIns="53950" bIns="26975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Zn2 binding motif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7" name="Text Box 13"/>
          <p:cNvSpPr txBox="1">
            <a:spLocks noChangeArrowheads="1"/>
          </p:cNvSpPr>
          <p:nvPr/>
        </p:nvSpPr>
        <p:spPr bwMode="auto">
          <a:xfrm>
            <a:off x="5128079" y="4868987"/>
            <a:ext cx="2145279" cy="2525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3950" tIns="26975" rIns="53950" bIns="26975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NADPH binding motif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9393596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42</Words>
  <Application>Microsoft Office PowerPoint</Application>
  <PresentationFormat>全屏显示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Lenov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C SYSTEM</dc:creator>
  <cp:lastModifiedBy>MC SYSTEM</cp:lastModifiedBy>
  <cp:revision>2</cp:revision>
  <dcterms:created xsi:type="dcterms:W3CDTF">2015-04-21T06:28:24Z</dcterms:created>
  <dcterms:modified xsi:type="dcterms:W3CDTF">2015-06-07T09:01:49Z</dcterms:modified>
</cp:coreProperties>
</file>